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0" r:id="rId2"/>
    <p:sldId id="271" r:id="rId3"/>
    <p:sldId id="269" r:id="rId4"/>
    <p:sldId id="266" r:id="rId5"/>
    <p:sldId id="276" r:id="rId6"/>
    <p:sldId id="272" r:id="rId7"/>
    <p:sldId id="268" r:id="rId8"/>
    <p:sldId id="273" r:id="rId9"/>
    <p:sldId id="274" r:id="rId10"/>
    <p:sldId id="27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image" Target="../media/image25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image" Target="../media/image38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image" Target="../media/image41.emf"/><Relationship Id="rId6" Type="http://schemas.openxmlformats.org/officeDocument/2006/relationships/image" Target="../media/image46.emf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image" Target="../media/image5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F87150-F215-4C14-A653-BBDFC9B17C1A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231C55-7EE7-48A7-8223-B51588E0C4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0338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78" indent="0" algn="ctr">
              <a:buNone/>
              <a:defRPr sz="2000"/>
            </a:lvl2pPr>
            <a:lvl3pPr marL="914354" indent="0" algn="ctr">
              <a:buNone/>
              <a:defRPr sz="1800"/>
            </a:lvl3pPr>
            <a:lvl4pPr marL="1371532" indent="0" algn="ctr">
              <a:buNone/>
              <a:defRPr sz="1600"/>
            </a:lvl4pPr>
            <a:lvl5pPr marL="1828709" indent="0" algn="ctr">
              <a:buNone/>
              <a:defRPr sz="1600"/>
            </a:lvl5pPr>
            <a:lvl6pPr marL="2285886" indent="0" algn="ctr">
              <a:buNone/>
              <a:defRPr sz="1600"/>
            </a:lvl6pPr>
            <a:lvl7pPr marL="2743062" indent="0" algn="ctr">
              <a:buNone/>
              <a:defRPr sz="1600"/>
            </a:lvl7pPr>
            <a:lvl8pPr marL="3200240" indent="0" algn="ctr">
              <a:buNone/>
              <a:defRPr sz="1600"/>
            </a:lvl8pPr>
            <a:lvl9pPr marL="3657418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86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628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2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026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45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2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7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5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6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820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83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9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4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2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4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2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23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511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171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8" indent="0">
              <a:buNone/>
              <a:defRPr sz="1400"/>
            </a:lvl2pPr>
            <a:lvl3pPr marL="914354" indent="0">
              <a:buNone/>
              <a:defRPr sz="1200"/>
            </a:lvl3pPr>
            <a:lvl4pPr marL="1371532" indent="0">
              <a:buNone/>
              <a:defRPr sz="1000"/>
            </a:lvl4pPr>
            <a:lvl5pPr marL="1828709" indent="0">
              <a:buNone/>
              <a:defRPr sz="1000"/>
            </a:lvl5pPr>
            <a:lvl6pPr marL="2285886" indent="0">
              <a:buNone/>
              <a:defRPr sz="1000"/>
            </a:lvl6pPr>
            <a:lvl7pPr marL="2743062" indent="0">
              <a:buNone/>
              <a:defRPr sz="1000"/>
            </a:lvl7pPr>
            <a:lvl8pPr marL="3200240" indent="0">
              <a:buNone/>
              <a:defRPr sz="1000"/>
            </a:lvl8pPr>
            <a:lvl9pPr marL="36574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17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9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78" indent="0">
              <a:buNone/>
              <a:defRPr sz="2800"/>
            </a:lvl2pPr>
            <a:lvl3pPr marL="914354" indent="0">
              <a:buNone/>
              <a:defRPr sz="2400"/>
            </a:lvl3pPr>
            <a:lvl4pPr marL="1371532" indent="0">
              <a:buNone/>
              <a:defRPr sz="2000"/>
            </a:lvl4pPr>
            <a:lvl5pPr marL="1828709" indent="0">
              <a:buNone/>
              <a:defRPr sz="2000"/>
            </a:lvl5pPr>
            <a:lvl6pPr marL="2285886" indent="0">
              <a:buNone/>
              <a:defRPr sz="2000"/>
            </a:lvl6pPr>
            <a:lvl7pPr marL="2743062" indent="0">
              <a:buNone/>
              <a:defRPr sz="2000"/>
            </a:lvl7pPr>
            <a:lvl8pPr marL="3200240" indent="0">
              <a:buNone/>
              <a:defRPr sz="2000"/>
            </a:lvl8pPr>
            <a:lvl9pPr marL="365741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8" indent="0">
              <a:buNone/>
              <a:defRPr sz="1400"/>
            </a:lvl2pPr>
            <a:lvl3pPr marL="914354" indent="0">
              <a:buNone/>
              <a:defRPr sz="1200"/>
            </a:lvl3pPr>
            <a:lvl4pPr marL="1371532" indent="0">
              <a:buNone/>
              <a:defRPr sz="1000"/>
            </a:lvl4pPr>
            <a:lvl5pPr marL="1828709" indent="0">
              <a:buNone/>
              <a:defRPr sz="1000"/>
            </a:lvl5pPr>
            <a:lvl6pPr marL="2285886" indent="0">
              <a:buNone/>
              <a:defRPr sz="1000"/>
            </a:lvl6pPr>
            <a:lvl7pPr marL="2743062" indent="0">
              <a:buNone/>
              <a:defRPr sz="1000"/>
            </a:lvl7pPr>
            <a:lvl8pPr marL="3200240" indent="0">
              <a:buNone/>
              <a:defRPr sz="1000"/>
            </a:lvl8pPr>
            <a:lvl9pPr marL="3657418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28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9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76C70-AC4F-40F8-BEC3-738D65B4B283}" type="datetimeFigureOut">
              <a:rPr lang="en-US" smtClean="0"/>
              <a:t>3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EE1CA7-87FA-4D9C-851E-6BA1EE663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495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54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9" indent="-228589" algn="l" defTabSz="9143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66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42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20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98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74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52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29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06" indent="-228589" algn="l" defTabSz="91435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8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4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2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09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86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62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40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18" algn="l" defTabSz="9143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3" Type="http://schemas.openxmlformats.org/officeDocument/2006/relationships/oleObject" Target="../embeddings/oleObject21.bin"/><Relationship Id="rId7" Type="http://schemas.openxmlformats.org/officeDocument/2006/relationships/oleObject" Target="../embeddings/oleObject2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51.emf"/><Relationship Id="rId5" Type="http://schemas.openxmlformats.org/officeDocument/2006/relationships/oleObject" Target="../embeddings/oleObject22.bin"/><Relationship Id="rId4" Type="http://schemas.openxmlformats.org/officeDocument/2006/relationships/image" Target="../media/image50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9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4.png"/><Relationship Id="rId21" Type="http://schemas.openxmlformats.org/officeDocument/2006/relationships/image" Target="../media/image13.png"/><Relationship Id="rId34" Type="http://schemas.openxmlformats.org/officeDocument/2006/relationships/image" Target="../media/image1.emf"/><Relationship Id="rId7" Type="http://schemas.openxmlformats.org/officeDocument/2006/relationships/image" Target="../media/image6.png"/><Relationship Id="rId12" Type="http://schemas.microsoft.com/office/2007/relationships/hdphoto" Target="../media/hdphoto5.wdp"/><Relationship Id="rId17" Type="http://schemas.openxmlformats.org/officeDocument/2006/relationships/image" Target="../media/image11.png"/><Relationship Id="rId25" Type="http://schemas.openxmlformats.org/officeDocument/2006/relationships/image" Target="../media/image15.png"/><Relationship Id="rId33" Type="http://schemas.openxmlformats.org/officeDocument/2006/relationships/oleObject" Target="../embeddings/oleObject1.bin"/><Relationship Id="rId38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7.png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oleObject" Target="../embeddings/oleObject3.bin"/><Relationship Id="rId5" Type="http://schemas.openxmlformats.org/officeDocument/2006/relationships/image" Target="../media/image5.png"/><Relationship Id="rId15" Type="http://schemas.openxmlformats.org/officeDocument/2006/relationships/image" Target="../media/image10.png"/><Relationship Id="rId23" Type="http://schemas.openxmlformats.org/officeDocument/2006/relationships/image" Target="../media/image14.png"/><Relationship Id="rId28" Type="http://schemas.microsoft.com/office/2007/relationships/hdphoto" Target="../media/hdphoto13.wdp"/><Relationship Id="rId36" Type="http://schemas.openxmlformats.org/officeDocument/2006/relationships/image" Target="../media/image2.emf"/><Relationship Id="rId10" Type="http://schemas.microsoft.com/office/2007/relationships/hdphoto" Target="../media/hdphoto4.wdp"/><Relationship Id="rId19" Type="http://schemas.openxmlformats.org/officeDocument/2006/relationships/image" Target="../media/image12.png"/><Relationship Id="rId31" Type="http://schemas.openxmlformats.org/officeDocument/2006/relationships/image" Target="../media/image18.png"/><Relationship Id="rId4" Type="http://schemas.microsoft.com/office/2007/relationships/hdphoto" Target="../media/hdphoto1.wdp"/><Relationship Id="rId9" Type="http://schemas.openxmlformats.org/officeDocument/2006/relationships/image" Target="../media/image7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6.png"/><Relationship Id="rId30" Type="http://schemas.microsoft.com/office/2007/relationships/hdphoto" Target="../media/hdphoto14.wdp"/><Relationship Id="rId35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0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2.e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24.emf"/><Relationship Id="rId4" Type="http://schemas.openxmlformats.org/officeDocument/2006/relationships/image" Target="../media/image21.emf"/><Relationship Id="rId9" Type="http://schemas.openxmlformats.org/officeDocument/2006/relationships/oleObject" Target="../embeddings/oleObject9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f"/><Relationship Id="rId13" Type="http://schemas.openxmlformats.org/officeDocument/2006/relationships/image" Target="../media/image34.tiff"/><Relationship Id="rId18" Type="http://schemas.openxmlformats.org/officeDocument/2006/relationships/image" Target="../media/image25.emf"/><Relationship Id="rId3" Type="http://schemas.openxmlformats.org/officeDocument/2006/relationships/image" Target="../media/image27.png"/><Relationship Id="rId7" Type="http://schemas.openxmlformats.org/officeDocument/2006/relationships/image" Target="../media/image30.tiff"/><Relationship Id="rId12" Type="http://schemas.microsoft.com/office/2007/relationships/hdphoto" Target="../media/hdphoto18.wdp"/><Relationship Id="rId1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png"/><Relationship Id="rId20" Type="http://schemas.openxmlformats.org/officeDocument/2006/relationships/image" Target="../media/image26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29.tiff"/><Relationship Id="rId11" Type="http://schemas.openxmlformats.org/officeDocument/2006/relationships/image" Target="../media/image33.png"/><Relationship Id="rId5" Type="http://schemas.openxmlformats.org/officeDocument/2006/relationships/image" Target="../media/image28.png"/><Relationship Id="rId15" Type="http://schemas.openxmlformats.org/officeDocument/2006/relationships/image" Target="../media/image36.png"/><Relationship Id="rId10" Type="http://schemas.microsoft.com/office/2007/relationships/hdphoto" Target="../media/hdphoto17.wdp"/><Relationship Id="rId19" Type="http://schemas.openxmlformats.org/officeDocument/2006/relationships/oleObject" Target="../embeddings/oleObject11.bin"/><Relationship Id="rId4" Type="http://schemas.microsoft.com/office/2007/relationships/hdphoto" Target="../media/hdphoto16.wdp"/><Relationship Id="rId9" Type="http://schemas.openxmlformats.org/officeDocument/2006/relationships/image" Target="../media/image32.png"/><Relationship Id="rId14" Type="http://schemas.openxmlformats.org/officeDocument/2006/relationships/image" Target="../media/image3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39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3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40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13" Type="http://schemas.openxmlformats.org/officeDocument/2006/relationships/oleObject" Target="../embeddings/oleObject20.bin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4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42.e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0" Type="http://schemas.openxmlformats.org/officeDocument/2006/relationships/image" Target="../media/image44.emf"/><Relationship Id="rId4" Type="http://schemas.openxmlformats.org/officeDocument/2006/relationships/image" Target="../media/image41.e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46.emf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9.wdp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tiff"/><Relationship Id="rId5" Type="http://schemas.microsoft.com/office/2007/relationships/hdphoto" Target="../media/hdphoto20.wdp"/><Relationship Id="rId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3CFFDE8-B0D4-412C-B82F-6BC23BC28D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96291" y="1805854"/>
            <a:ext cx="9144000" cy="2387600"/>
          </a:xfrm>
        </p:spPr>
        <p:txBody>
          <a:bodyPr/>
          <a:lstStyle/>
          <a:p>
            <a:r>
              <a:rPr lang="en-US" dirty="0"/>
              <a:t>Supplementary Figures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29387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765750" y="1247322"/>
            <a:ext cx="5076284" cy="3999592"/>
            <a:chOff x="5569796" y="1879135"/>
            <a:chExt cx="2494568" cy="1965464"/>
          </a:xfrm>
        </p:grpSpPr>
        <p:graphicFrame>
          <p:nvGraphicFramePr>
            <p:cNvPr id="6" name="Object 5"/>
            <p:cNvGraphicFramePr>
              <a:graphicFrameLocks noChangeAspect="1"/>
            </p:cNvGraphicFramePr>
            <p:nvPr/>
          </p:nvGraphicFramePr>
          <p:xfrm>
            <a:off x="5569796" y="1886335"/>
            <a:ext cx="1075294" cy="19582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28" name="Prism 6" r:id="rId3" imgW="2523280" imgH="4592750" progId="Prism6.Document">
                    <p:embed/>
                  </p:oleObj>
                </mc:Choice>
                <mc:Fallback>
                  <p:oleObj name="Prism 6" r:id="rId3" imgW="2523280" imgH="4592750" progId="Prism6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569796" y="1886335"/>
                          <a:ext cx="1075294" cy="19582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7151616"/>
                </p:ext>
              </p:extLst>
            </p:nvPr>
          </p:nvGraphicFramePr>
          <p:xfrm>
            <a:off x="6859532" y="1879135"/>
            <a:ext cx="1204832" cy="19523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29" name="Prism 6" r:id="rId5" imgW="2825281" imgH="4583751" progId="Prism6.Document">
                    <p:embed/>
                  </p:oleObj>
                </mc:Choice>
                <mc:Fallback>
                  <p:oleObj name="Prism 6" r:id="rId5" imgW="2825281" imgH="4583751" progId="Prism6.Document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859532" y="1879135"/>
                          <a:ext cx="1204832" cy="19523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25659"/>
              </p:ext>
            </p:extLst>
          </p:nvPr>
        </p:nvGraphicFramePr>
        <p:xfrm>
          <a:off x="679450" y="1400175"/>
          <a:ext cx="3490913" cy="3076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0" name="Prism 6" r:id="rId7" imgW="3992825" imgH="3467203" progId="Prism6.Document">
                  <p:embed/>
                </p:oleObj>
              </mc:Choice>
              <mc:Fallback>
                <p:oleObj name="Prism 6" r:id="rId7" imgW="3992825" imgH="3467203" progId="Prism6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79450" y="1400175"/>
                        <a:ext cx="3490913" cy="3076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36481" y="882247"/>
            <a:ext cx="3777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451107" y="921903"/>
            <a:ext cx="3777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195580" y="71815"/>
            <a:ext cx="2734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B21396-30A8-44F7-949C-233B1A45D9C5}"/>
              </a:ext>
            </a:extLst>
          </p:cNvPr>
          <p:cNvSpPr txBox="1"/>
          <p:nvPr/>
        </p:nvSpPr>
        <p:spPr>
          <a:xfrm>
            <a:off x="273219" y="5420702"/>
            <a:ext cx="1167844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9. ISC-4 is not toxic to mice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1498-Luc-dsRed-bearing Albino B6 mice were treated with either vehicle control or ISC-4 (7 mg/kg)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 changes was observed in body weight  or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mplete blood count (CBC) of animals throughout the study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S; not significant. </a:t>
            </a:r>
          </a:p>
        </p:txBody>
      </p:sp>
    </p:spTree>
    <p:extLst>
      <p:ext uri="{BB962C8B-B14F-4D97-AF65-F5344CB8AC3E}">
        <p14:creationId xmlns:p14="http://schemas.microsoft.com/office/powerpoint/2010/main" val="2449711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294985" y="3134741"/>
            <a:ext cx="4649588" cy="2371234"/>
            <a:chOff x="6043452" y="4426331"/>
            <a:chExt cx="5680025" cy="2896753"/>
          </a:xfrm>
        </p:grpSpPr>
        <p:grpSp>
          <p:nvGrpSpPr>
            <p:cNvPr id="11" name="Group 10"/>
            <p:cNvGrpSpPr/>
            <p:nvPr/>
          </p:nvGrpSpPr>
          <p:grpSpPr>
            <a:xfrm>
              <a:off x="6395030" y="4426331"/>
              <a:ext cx="5328447" cy="2896753"/>
              <a:chOff x="5977569" y="4652790"/>
              <a:chExt cx="6085519" cy="3308331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5977569" y="4652790"/>
                <a:ext cx="6085519" cy="1309131"/>
                <a:chOff x="-159769" y="2212357"/>
                <a:chExt cx="10733496" cy="2308998"/>
              </a:xfrm>
            </p:grpSpPr>
            <p:pic>
              <p:nvPicPr>
                <p:cNvPr id="30" name="Picture 29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240" t="5087" r="4562" b="7271"/>
                <a:stretch/>
              </p:blipFill>
              <p:spPr>
                <a:xfrm rot="5400000">
                  <a:off x="2092613" y="3029986"/>
                  <a:ext cx="1496659" cy="1486080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31" name="Picture 30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432" t="666" r="4562" b="8575"/>
                <a:stretch/>
              </p:blipFill>
              <p:spPr>
                <a:xfrm rot="5400000">
                  <a:off x="3842687" y="3034404"/>
                  <a:ext cx="1495640" cy="1475358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69" t="2599" r="4796" b="7577"/>
                <a:stretch/>
              </p:blipFill>
              <p:spPr>
                <a:xfrm rot="5400000">
                  <a:off x="7149524" y="3028664"/>
                  <a:ext cx="1496402" cy="1486080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33" name="Picture 32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005" t="1657" r="4562" b="10390"/>
                <a:stretch/>
              </p:blipFill>
              <p:spPr>
                <a:xfrm rot="5400000">
                  <a:off x="8870711" y="3026122"/>
                  <a:ext cx="1491528" cy="1486296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 rotWithShape="1"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598" t="4152" r="6607" b="9766"/>
                <a:stretch/>
              </p:blipFill>
              <p:spPr>
                <a:xfrm rot="5400000">
                  <a:off x="5485330" y="3031061"/>
                  <a:ext cx="1486648" cy="1481281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1820255" y="2212357"/>
                  <a:ext cx="1877411" cy="6816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3730990" y="2212357"/>
                  <a:ext cx="1616886" cy="6816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7064407" y="2212357"/>
                  <a:ext cx="1616886" cy="6816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8588767" y="2212357"/>
                  <a:ext cx="1984960" cy="6816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5375023" y="2212357"/>
                  <a:ext cx="1616886" cy="6816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-159769" y="3328609"/>
                  <a:ext cx="2147811" cy="11360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L 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t. 1290</a:t>
                  </a: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6024270" y="6108751"/>
                <a:ext cx="5943867" cy="875442"/>
                <a:chOff x="-69374" y="2987771"/>
                <a:chExt cx="9009127" cy="1326912"/>
              </a:xfrm>
            </p:grpSpPr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070" t="6959" r="1988" b="1657"/>
                <a:stretch/>
              </p:blipFill>
              <p:spPr>
                <a:xfrm rot="5400000">
                  <a:off x="4705693" y="3000982"/>
                  <a:ext cx="1316493" cy="1290072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5" name="Picture 24"/>
                <p:cNvPicPr>
                  <a:picLocks noChangeAspect="1"/>
                </p:cNvPicPr>
                <p:nvPr/>
              </p:nvPicPr>
              <p:blipFill rotWithShape="1">
                <a:blip r:embed="rId15" cstate="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240" t="2905" r="1521" b="5399"/>
                <a:stretch/>
              </p:blipFill>
              <p:spPr>
                <a:xfrm rot="5400000">
                  <a:off x="7632042" y="3006972"/>
                  <a:ext cx="1312142" cy="1303280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 rotWithShape="1">
                <a:blip r:embed="rId17" cstate="print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240" t="1969" r="2457" b="7271"/>
                <a:stretch/>
              </p:blipFill>
              <p:spPr>
                <a:xfrm rot="5400000">
                  <a:off x="1756385" y="2990029"/>
                  <a:ext cx="1316491" cy="1311982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 rotWithShape="1">
                <a:blip r:embed="rId19" cstate="print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302" t="3234" r="1458" b="5694"/>
                <a:stretch/>
              </p:blipFill>
              <p:spPr>
                <a:xfrm rot="5400000">
                  <a:off x="3290109" y="2996671"/>
                  <a:ext cx="1316492" cy="1298699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8" name="Picture 27"/>
                <p:cNvPicPr>
                  <a:picLocks noChangeAspect="1"/>
                </p:cNvPicPr>
                <p:nvPr/>
              </p:nvPicPr>
              <p:blipFill rotWithShape="1">
                <a:blip r:embed="rId21" cstate="print">
                  <a:extLst>
                    <a:ext uri="{BEBA8EAE-BF5A-486C-A8C5-ECC9F3942E4B}">
                      <a14:imgProps xmlns:a14="http://schemas.microsoft.com/office/drawing/2010/main">
                        <a14:imgLayer r:embed="rId22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772" t="1969" r="1989" b="5711"/>
                <a:stretch/>
              </p:blipFill>
              <p:spPr>
                <a:xfrm rot="5400000">
                  <a:off x="6129750" y="2987773"/>
                  <a:ext cx="1326908" cy="1326910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sp>
              <p:nvSpPr>
                <p:cNvPr id="29" name="TextBox 28"/>
                <p:cNvSpPr txBox="1"/>
                <p:nvPr/>
              </p:nvSpPr>
              <p:spPr>
                <a:xfrm>
                  <a:off x="-69374" y="3232597"/>
                  <a:ext cx="1733702" cy="9762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L 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t. 1241</a:t>
                  </a:r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7257589" y="7063163"/>
                <a:ext cx="4682828" cy="847273"/>
                <a:chOff x="1044666" y="3368506"/>
                <a:chExt cx="11961050" cy="2164121"/>
              </a:xfrm>
            </p:grpSpPr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 rotWithShape="1">
                <a:blip r:embed="rId23" cstate="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sharpenSoften amount="50000"/>
                          </a14:imgEffect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679" t="4847" r="9122" b="6888"/>
                <a:stretch/>
              </p:blipFill>
              <p:spPr>
                <a:xfrm rot="5400000">
                  <a:off x="3553060" y="3368979"/>
                  <a:ext cx="2141289" cy="2141287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0" name="Picture 19"/>
                <p:cNvPicPr>
                  <a:picLocks noChangeAspect="1"/>
                </p:cNvPicPr>
                <p:nvPr/>
              </p:nvPicPr>
              <p:blipFill rotWithShape="1">
                <a:blip r:embed="rId25" cstate="print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sharpenSoften amount="50000"/>
                          </a14:imgEffect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63" t="4776" r="7603" b="5400"/>
                <a:stretch/>
              </p:blipFill>
              <p:spPr>
                <a:xfrm rot="5400000">
                  <a:off x="5940166" y="3366483"/>
                  <a:ext cx="2162378" cy="2169909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27" cstate="print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sharpenSoften amount="50000"/>
                          </a14:imgEffect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369" t="6367" r="5029" b="4745"/>
                <a:stretch/>
              </p:blipFill>
              <p:spPr>
                <a:xfrm rot="5400000">
                  <a:off x="8407214" y="3383272"/>
                  <a:ext cx="2133414" cy="2103881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 rotWithShape="1">
                <a:blip r:embed="rId29" cstate="print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sharpenSoften amount="50000"/>
                          </a14:imgEffect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085" t="4990" r="4780" b="4561"/>
                <a:stretch/>
              </p:blipFill>
              <p:spPr>
                <a:xfrm rot="5400000">
                  <a:off x="1055734" y="3371710"/>
                  <a:ext cx="2119150" cy="2141285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 rotWithShape="1">
                <a:blip r:embed="rId31" cstate="print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sharpenSoften amount="50000"/>
                          </a14:imgEffect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608" t="10389" r="18129" b="2905"/>
                <a:stretch/>
              </p:blipFill>
              <p:spPr>
                <a:xfrm rot="5400000">
                  <a:off x="10884846" y="3381060"/>
                  <a:ext cx="2124678" cy="2117063"/>
                </a:xfrm>
                <a:prstGeom prst="ellipse">
                  <a:avLst/>
                </a:prstGeom>
                <a:ln w="63500" cap="rnd">
                  <a:noFill/>
                </a:ln>
                <a:effectLst/>
                <a:scene3d>
                  <a:camera prst="orthographicFront"/>
                  <a:lightRig rig="contrasting" dir="t">
                    <a:rot lat="0" lon="0" rev="3000000"/>
                  </a:lightRig>
                </a:scene3d>
                <a:sp3d contourW="7620">
                  <a:bevelT w="95250" h="31750"/>
                  <a:contourClr>
                    <a:srgbClr val="333333"/>
                  </a:contourClr>
                </a:sp3d>
              </p:spPr>
            </p:pic>
          </p:grpSp>
          <p:sp>
            <p:nvSpPr>
              <p:cNvPr id="18" name="TextBox 17"/>
              <p:cNvSpPr txBox="1"/>
              <p:nvPr/>
            </p:nvSpPr>
            <p:spPr>
              <a:xfrm>
                <a:off x="6004774" y="7317009"/>
                <a:ext cx="1206188" cy="6441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B MNCs</a:t>
                </a: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6043452" y="4445470"/>
              <a:ext cx="1834614" cy="338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C-4 (µM)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133152" y="67832"/>
            <a:ext cx="2734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14471" y="5960253"/>
            <a:ext cx="1158152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A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C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values of single-agent treatments or a combination of constant ISC-4 (5 µM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creasing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ra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0.75-24 µM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centrations a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4, 48 and 72 h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Representative images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lonies of primary AML and cord blood (CB MNCs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s expos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o ISC-4 (1-10 µM) for 7-14 days in a methylcellulose  media. 4X magnification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lonogenicity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of cells pretreated with ISC-4 for 24 hours. </a:t>
            </a:r>
          </a:p>
        </p:txBody>
      </p:sp>
      <p:graphicFrame>
        <p:nvGraphicFramePr>
          <p:cNvPr id="42" name="Object 4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2989841"/>
              </p:ext>
            </p:extLst>
          </p:nvPr>
        </p:nvGraphicFramePr>
        <p:xfrm>
          <a:off x="7237070" y="3043652"/>
          <a:ext cx="3537827" cy="24952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89" name="Prism 6" r:id="rId33" imgW="5162185" imgH="3650161" progId="Prism6.Document">
                  <p:embed/>
                </p:oleObj>
              </mc:Choice>
              <mc:Fallback>
                <p:oleObj name="Prism 6" r:id="rId33" imgW="5162185" imgH="3650161" progId="Prism6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7237070" y="3043652"/>
                        <a:ext cx="3537827" cy="24952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TextBox 42"/>
          <p:cNvSpPr txBox="1"/>
          <p:nvPr/>
        </p:nvSpPr>
        <p:spPr>
          <a:xfrm>
            <a:off x="686475" y="861146"/>
            <a:ext cx="341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86475" y="3016557"/>
            <a:ext cx="341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418077" y="731309"/>
            <a:ext cx="6727515" cy="1880441"/>
            <a:chOff x="1648036" y="817376"/>
            <a:chExt cx="6348993" cy="1774638"/>
          </a:xfrm>
        </p:grpSpPr>
        <p:graphicFrame>
          <p:nvGraphicFramePr>
            <p:cNvPr id="45" name="Object 4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9023028"/>
                </p:ext>
              </p:extLst>
            </p:nvPr>
          </p:nvGraphicFramePr>
          <p:xfrm>
            <a:off x="4800357" y="855508"/>
            <a:ext cx="3196672" cy="17365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690" name="Prism 6" r:id="rId35" imgW="6268882" imgH="3405977" progId="Prism6.Document">
                    <p:embed/>
                  </p:oleObj>
                </mc:Choice>
                <mc:Fallback>
                  <p:oleObj name="Prism 6" r:id="rId35" imgW="6268882" imgH="3405977" progId="Prism6.Document">
                    <p:embed/>
                    <p:pic>
                      <p:nvPicPr>
                        <p:cNvPr id="24" name="Object 23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4800357" y="855508"/>
                          <a:ext cx="3196672" cy="17365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6" name="Object 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54714921"/>
                </p:ext>
              </p:extLst>
            </p:nvPr>
          </p:nvGraphicFramePr>
          <p:xfrm>
            <a:off x="1648036" y="817376"/>
            <a:ext cx="3152321" cy="1738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691" name="Prism 6" r:id="rId37" imgW="6177408" imgH="3407778" progId="Prism6.Document">
                    <p:embed/>
                  </p:oleObj>
                </mc:Choice>
                <mc:Fallback>
                  <p:oleObj name="Prism 6" r:id="rId37" imgW="6177408" imgH="3407778" progId="Prism6.Document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1648036" y="817376"/>
                          <a:ext cx="3152321" cy="1738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7" name="TextBox 46"/>
          <p:cNvSpPr txBox="1"/>
          <p:nvPr/>
        </p:nvSpPr>
        <p:spPr>
          <a:xfrm>
            <a:off x="6883436" y="3016557"/>
            <a:ext cx="341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34665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3841677"/>
              </p:ext>
            </p:extLst>
          </p:nvPr>
        </p:nvGraphicFramePr>
        <p:xfrm>
          <a:off x="6860271" y="1998663"/>
          <a:ext cx="3919100" cy="2512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38" name="Prism 6" r:id="rId3" imgW="3796191" imgH="2433201" progId="Prism6.Document">
                  <p:embed/>
                </p:oleObj>
              </mc:Choice>
              <mc:Fallback>
                <p:oleObj name="Prism 6" r:id="rId3" imgW="3796191" imgH="2433201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860271" y="1998663"/>
                        <a:ext cx="3919100" cy="2512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5632530"/>
              </p:ext>
            </p:extLst>
          </p:nvPr>
        </p:nvGraphicFramePr>
        <p:xfrm>
          <a:off x="630238" y="1998663"/>
          <a:ext cx="4251325" cy="254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39" name="Prism 6" r:id="rId5" imgW="3966895" imgH="2369453" progId="Prism6.Document">
                  <p:embed/>
                </p:oleObj>
              </mc:Choice>
              <mc:Fallback>
                <p:oleObj name="Prism 6" r:id="rId5" imgW="3966895" imgH="2369453" progId="Prism6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30238" y="1998663"/>
                        <a:ext cx="4251325" cy="254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323263" y="146839"/>
            <a:ext cx="2734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8395" y="5413707"/>
            <a:ext cx="115051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2. A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Effect of ISC-4 on normal premature cells (CD34+ or CD123+) in cord bloo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B MNCs)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iability of  normal T (CD3+), B (CD19+) or myeloid (CD11b+) cells in response to ISC-4 treatment in normal peripheral blood mononuclear cells (PBMC)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e frequency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f cell populations in th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samples shown on the right pane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Viability was assessed by 7AAD staining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4564" y="1519888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565906" y="1519888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/>
              <a:t>B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6176078"/>
              </p:ext>
            </p:extLst>
          </p:nvPr>
        </p:nvGraphicFramePr>
        <p:xfrm>
          <a:off x="4811451" y="2464650"/>
          <a:ext cx="1256442" cy="13716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256442">
                  <a:extLst>
                    <a:ext uri="{9D8B030D-6E8A-4147-A177-3AD203B41FA5}">
                      <a16:colId xmlns:a16="http://schemas.microsoft.com/office/drawing/2014/main" val="3343281480"/>
                    </a:ext>
                  </a:extLst>
                </a:gridCol>
              </a:tblGrid>
              <a:tr h="18871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Frequency</a:t>
                      </a:r>
                      <a:r>
                        <a:rPr lang="en-US" sz="1200" b="1" baseline="0" dirty="0"/>
                        <a:t> (%)</a:t>
                      </a:r>
                      <a:endParaRPr 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0577067"/>
                  </a:ext>
                </a:extLst>
              </a:tr>
              <a:tr h="18871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3.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124243"/>
                  </a:ext>
                </a:extLst>
              </a:tr>
              <a:tr h="18871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2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1465257"/>
                  </a:ext>
                </a:extLst>
              </a:tr>
              <a:tr h="18871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7.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0289805"/>
                  </a:ext>
                </a:extLst>
              </a:tr>
              <a:tr h="18871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4.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8198540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9853274"/>
              </p:ext>
            </p:extLst>
          </p:nvPr>
        </p:nvGraphicFramePr>
        <p:xfrm>
          <a:off x="10703903" y="2199826"/>
          <a:ext cx="1199626" cy="1441208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99626">
                  <a:extLst>
                    <a:ext uri="{9D8B030D-6E8A-4147-A177-3AD203B41FA5}">
                      <a16:colId xmlns:a16="http://schemas.microsoft.com/office/drawing/2014/main" val="3343281480"/>
                    </a:ext>
                  </a:extLst>
                </a:gridCol>
              </a:tblGrid>
              <a:tr h="343928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Frequency</a:t>
                      </a:r>
                      <a:r>
                        <a:rPr lang="en-US" sz="1200" b="1" baseline="0" dirty="0"/>
                        <a:t> (%)</a:t>
                      </a:r>
                      <a:endParaRPr 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0577067"/>
                  </a:ext>
                </a:extLst>
              </a:tr>
              <a:tr h="22304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94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124243"/>
                  </a:ext>
                </a:extLst>
              </a:tr>
              <a:tr h="22304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60.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1465257"/>
                  </a:ext>
                </a:extLst>
              </a:tr>
              <a:tr h="22304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0289805"/>
                  </a:ext>
                </a:extLst>
              </a:tr>
              <a:tr h="223043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.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81985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250803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7890840"/>
              </p:ext>
            </p:extLst>
          </p:nvPr>
        </p:nvGraphicFramePr>
        <p:xfrm>
          <a:off x="1933920" y="3048468"/>
          <a:ext cx="3229522" cy="1911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913" name="Prism 6" r:id="rId3" imgW="5189556" imgH="3073555" progId="Prism6.Document">
                  <p:embed/>
                </p:oleObj>
              </mc:Choice>
              <mc:Fallback>
                <p:oleObj name="Prism 6" r:id="rId3" imgW="5189556" imgH="3073555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33920" y="3048468"/>
                        <a:ext cx="3229522" cy="19115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145571" y="105708"/>
            <a:ext cx="2734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3054" y="5953669"/>
            <a:ext cx="1105675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fficacy of ISC-4 on apoptosis at various time points in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MV4-11 and OCI-AML3;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rimary human AML cell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ta are the mean ± standard deviation (SD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52476" y="716912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121620" y="692474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500" b="1" dirty="0"/>
              <a:t>B</a:t>
            </a: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452777"/>
              </p:ext>
            </p:extLst>
          </p:nvPr>
        </p:nvGraphicFramePr>
        <p:xfrm>
          <a:off x="6474435" y="3048468"/>
          <a:ext cx="3275013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914" name="Prism 6" r:id="rId5" imgW="6104300" imgH="3887863" progId="Prism6.Document">
                  <p:embed/>
                </p:oleObj>
              </mc:Choice>
              <mc:Fallback>
                <p:oleObj name="Prism 6" r:id="rId5" imgW="6104300" imgH="3887863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74435" y="3048468"/>
                        <a:ext cx="3275013" cy="208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2971213"/>
              </p:ext>
            </p:extLst>
          </p:nvPr>
        </p:nvGraphicFramePr>
        <p:xfrm>
          <a:off x="6429986" y="955439"/>
          <a:ext cx="3319462" cy="2000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915" name="Prism 6" r:id="rId7" imgW="6192894" imgH="3732276" progId="Prism6.Document">
                  <p:embed/>
                </p:oleObj>
              </mc:Choice>
              <mc:Fallback>
                <p:oleObj name="Prism 6" r:id="rId7" imgW="6192894" imgH="3732276" progId="Prism6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429986" y="955439"/>
                        <a:ext cx="3319462" cy="2000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1785780"/>
              </p:ext>
            </p:extLst>
          </p:nvPr>
        </p:nvGraphicFramePr>
        <p:xfrm>
          <a:off x="1840885" y="1031069"/>
          <a:ext cx="3415592" cy="19105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916" name="Prism 6" r:id="rId9" imgW="5872733" imgH="3284245" progId="Prism6.Document">
                  <p:embed/>
                </p:oleObj>
              </mc:Choice>
              <mc:Fallback>
                <p:oleObj name="Prism 6" r:id="rId9" imgW="5872733" imgH="3284245" progId="Prism6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40885" y="1031069"/>
                        <a:ext cx="3415592" cy="19105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541482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151478" y="15660"/>
            <a:ext cx="2734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51478" y="5650080"/>
            <a:ext cx="119397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lot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alysis of OCI-AML3 cells exposed to increasing concentrations of ISC-4 for 6 or 12 hours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Flow cytometric analysis of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multicaspase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s 1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, 3, 4, 5, 6, 7, 8, and 9), </a:t>
            </a:r>
            <a:r>
              <a:rPr lang="en-US" sz="1600" dirty="0">
                <a:solidFill>
                  <a:srgbClr val="2E2E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600" b="1" dirty="0">
                <a:solidFill>
                  <a:srgbClr val="2E2E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600" dirty="0">
                <a:solidFill>
                  <a:srgbClr val="2E2E2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chondrial membrane potential in OCI-AML3 cells after treatment with ISC-4 (1-10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µM) for 6 or 24 hours.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85377" y="759075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604650" y="2929569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C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604650" y="759075"/>
            <a:ext cx="377711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B</a:t>
            </a:r>
          </a:p>
        </p:txBody>
      </p:sp>
      <p:grpSp>
        <p:nvGrpSpPr>
          <p:cNvPr id="102" name="Group 101"/>
          <p:cNvGrpSpPr/>
          <p:nvPr/>
        </p:nvGrpSpPr>
        <p:grpSpPr>
          <a:xfrm>
            <a:off x="169950" y="847320"/>
            <a:ext cx="6834563" cy="3811872"/>
            <a:chOff x="37224" y="1181230"/>
            <a:chExt cx="6834563" cy="3811872"/>
          </a:xfrm>
        </p:grpSpPr>
        <p:sp>
          <p:nvSpPr>
            <p:cNvPr id="53" name="TextBox 52"/>
            <p:cNvSpPr txBox="1"/>
            <p:nvPr/>
          </p:nvSpPr>
          <p:spPr>
            <a:xfrm>
              <a:off x="1993872" y="1472751"/>
              <a:ext cx="18127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</a:p>
          </p:txBody>
        </p:sp>
        <p:grpSp>
          <p:nvGrpSpPr>
            <p:cNvPr id="54" name="Group 53"/>
            <p:cNvGrpSpPr/>
            <p:nvPr/>
          </p:nvGrpSpPr>
          <p:grpSpPr>
            <a:xfrm>
              <a:off x="2036608" y="1811545"/>
              <a:ext cx="1770918" cy="277001"/>
              <a:chOff x="1260843" y="1141330"/>
              <a:chExt cx="1781720" cy="278689"/>
            </a:xfrm>
          </p:grpSpPr>
          <p:sp>
            <p:nvSpPr>
              <p:cNvPr id="96" name="TextBox 95"/>
              <p:cNvSpPr txBox="1"/>
              <p:nvPr/>
            </p:nvSpPr>
            <p:spPr>
              <a:xfrm>
                <a:off x="1260843" y="1141332"/>
                <a:ext cx="374664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1717778" y="1141331"/>
                <a:ext cx="354242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2154292" y="1141332"/>
                <a:ext cx="399062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2560600" y="1141330"/>
                <a:ext cx="481963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739915" y="1816720"/>
              <a:ext cx="12145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C-4 (µM)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7224" y="2103825"/>
              <a:ext cx="19357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hospho-Akt (Ser473)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017497" y="2411058"/>
              <a:ext cx="936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017497" y="2698051"/>
              <a:ext cx="936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ARP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19076" y="2892202"/>
              <a:ext cx="1235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 PARP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07494" y="3714395"/>
              <a:ext cx="1646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 Caspase-3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017497" y="4703474"/>
              <a:ext cx="9369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07494" y="3288903"/>
              <a:ext cx="1646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3</a:t>
              </a:r>
            </a:p>
          </p:txBody>
        </p:sp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25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17" t="56619" r="57100" b="34644"/>
            <a:stretch/>
          </p:blipFill>
          <p:spPr>
            <a:xfrm>
              <a:off x="1973284" y="2105733"/>
              <a:ext cx="1832369" cy="2498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49" t="56619" r="24381" b="34643"/>
            <a:stretch/>
          </p:blipFill>
          <p:spPr>
            <a:xfrm>
              <a:off x="3955715" y="2105733"/>
              <a:ext cx="1831808" cy="2498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5" name="Picture 6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08" t="63373" r="59744" b="28049"/>
            <a:stretch/>
          </p:blipFill>
          <p:spPr>
            <a:xfrm>
              <a:off x="1973284" y="2411128"/>
              <a:ext cx="1832369" cy="2498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6" name="Picture 6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900" t="63373" r="27067" b="28049"/>
            <a:stretch/>
          </p:blipFill>
          <p:spPr>
            <a:xfrm>
              <a:off x="3955715" y="2411128"/>
              <a:ext cx="1831042" cy="2498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22" t="46584" r="62765" b="39912"/>
            <a:stretch/>
          </p:blipFill>
          <p:spPr>
            <a:xfrm>
              <a:off x="1973284" y="2716523"/>
              <a:ext cx="1832369" cy="3886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8" name="Picture 6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38" t="44655" r="29471" b="41843"/>
            <a:stretch/>
          </p:blipFill>
          <p:spPr>
            <a:xfrm>
              <a:off x="3955715" y="2716523"/>
              <a:ext cx="1831042" cy="3886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34" t="31800" r="59063" b="55786"/>
            <a:stretch/>
          </p:blipFill>
          <p:spPr>
            <a:xfrm>
              <a:off x="1973284" y="3160733"/>
              <a:ext cx="1832369" cy="4812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0" name="Picture 6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29" t="32798" r="26915" b="54788"/>
            <a:stretch/>
          </p:blipFill>
          <p:spPr>
            <a:xfrm>
              <a:off x="3955715" y="3160733"/>
              <a:ext cx="1822876" cy="4812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1" name="Picture 7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-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61" t="47662" r="26751" b="40039"/>
            <a:stretch/>
          </p:blipFill>
          <p:spPr>
            <a:xfrm>
              <a:off x="3955714" y="3686823"/>
              <a:ext cx="1822249" cy="3388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-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6" t="49927" r="58913" b="38265"/>
            <a:stretch/>
          </p:blipFill>
          <p:spPr>
            <a:xfrm>
              <a:off x="1973284" y="3686823"/>
              <a:ext cx="1832369" cy="3364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73" name="Group 72"/>
            <p:cNvGrpSpPr/>
            <p:nvPr/>
          </p:nvGrpSpPr>
          <p:grpSpPr>
            <a:xfrm>
              <a:off x="4015838" y="1811546"/>
              <a:ext cx="1770918" cy="277001"/>
              <a:chOff x="1260843" y="1141330"/>
              <a:chExt cx="1781720" cy="278689"/>
            </a:xfrm>
          </p:grpSpPr>
          <p:sp>
            <p:nvSpPr>
              <p:cNvPr id="92" name="TextBox 91"/>
              <p:cNvSpPr txBox="1"/>
              <p:nvPr/>
            </p:nvSpPr>
            <p:spPr>
              <a:xfrm>
                <a:off x="1260843" y="1141332"/>
                <a:ext cx="374664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717778" y="1141331"/>
                <a:ext cx="354242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2154292" y="1141332"/>
                <a:ext cx="399062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2560600" y="1141330"/>
                <a:ext cx="481963" cy="2786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</p:grpSp>
        <p:sp>
          <p:nvSpPr>
            <p:cNvPr id="74" name="TextBox 73"/>
            <p:cNvSpPr txBox="1"/>
            <p:nvPr/>
          </p:nvSpPr>
          <p:spPr>
            <a:xfrm>
              <a:off x="3982151" y="1472751"/>
              <a:ext cx="18046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2 h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07494" y="4372554"/>
              <a:ext cx="1646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 Caspase-9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07494" y="4095254"/>
              <a:ext cx="1646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spase-9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972284" y="1181230"/>
              <a:ext cx="36935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OCI-AML3</a:t>
              </a:r>
            </a:p>
          </p:txBody>
        </p:sp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35" t="39882" r="56557" b="39981"/>
            <a:stretch/>
          </p:blipFill>
          <p:spPr>
            <a:xfrm>
              <a:off x="1973284" y="4076918"/>
              <a:ext cx="1832369" cy="5822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9" name="Picture 78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052" t="39882" r="17812" b="41270"/>
            <a:stretch/>
          </p:blipFill>
          <p:spPr>
            <a:xfrm>
              <a:off x="3955715" y="4076918"/>
              <a:ext cx="1822248" cy="5597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0" name="Picture 79"/>
            <p:cNvPicPr>
              <a:picLocks noChangeAspect="1"/>
            </p:cNvPicPr>
            <p:nvPr/>
          </p:nvPicPr>
          <p:blipFill rotWithShape="1">
            <a:blip r:embed="rId15"/>
            <a:srcRect l="10578" t="21438" r="54989" b="66103"/>
            <a:stretch/>
          </p:blipFill>
          <p:spPr>
            <a:xfrm>
              <a:off x="1972284" y="4703666"/>
              <a:ext cx="1833368" cy="2894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Picture 80"/>
            <p:cNvPicPr>
              <a:picLocks noChangeAspect="1"/>
            </p:cNvPicPr>
            <p:nvPr/>
          </p:nvPicPr>
          <p:blipFill rotWithShape="1">
            <a:blip r:embed="rId16"/>
            <a:srcRect l="28785" t="21459" r="25301" b="66751"/>
            <a:stretch/>
          </p:blipFill>
          <p:spPr>
            <a:xfrm>
              <a:off x="3955715" y="4703666"/>
              <a:ext cx="1831042" cy="2894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82" name="Group 81"/>
            <p:cNvGrpSpPr/>
            <p:nvPr/>
          </p:nvGrpSpPr>
          <p:grpSpPr>
            <a:xfrm>
              <a:off x="5806912" y="2112019"/>
              <a:ext cx="1064875" cy="2869869"/>
              <a:chOff x="14824202" y="1491194"/>
              <a:chExt cx="2922703" cy="7876769"/>
            </a:xfrm>
          </p:grpSpPr>
          <p:sp>
            <p:nvSpPr>
              <p:cNvPr id="83" name="TextBox 82"/>
              <p:cNvSpPr txBox="1"/>
              <p:nvPr/>
            </p:nvSpPr>
            <p:spPr>
              <a:xfrm>
                <a:off x="14824202" y="1491194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 kDa</a:t>
                </a: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4824202" y="2322692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 kDa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14824202" y="3048000"/>
                <a:ext cx="2922703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16 kDa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14824202" y="4638025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 kDa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14824202" y="5939137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9 kDa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14824202" y="8649937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4824202" y="7018155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7 kDa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14824202" y="7708419"/>
                <a:ext cx="2426211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14824202" y="3681884"/>
                <a:ext cx="2922703" cy="7180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9 kDa</a:t>
                </a:r>
              </a:p>
            </p:txBody>
          </p:sp>
        </p:grpSp>
      </p:grpSp>
      <p:graphicFrame>
        <p:nvGraphicFramePr>
          <p:cNvPr id="100" name="Object 9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8314298"/>
              </p:ext>
            </p:extLst>
          </p:nvPr>
        </p:nvGraphicFramePr>
        <p:xfrm>
          <a:off x="8231547" y="752638"/>
          <a:ext cx="3085740" cy="2226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28" name="Prism 6" r:id="rId17" imgW="4157407" imgH="3000443" progId="Prism6.Document">
                  <p:embed/>
                </p:oleObj>
              </mc:Choice>
              <mc:Fallback>
                <p:oleObj name="Prism 6" r:id="rId17" imgW="4157407" imgH="3000443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231547" y="752638"/>
                        <a:ext cx="3085740" cy="2226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1" name="Object 10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9374196"/>
              </p:ext>
            </p:extLst>
          </p:nvPr>
        </p:nvGraphicFramePr>
        <p:xfrm>
          <a:off x="8265976" y="2949972"/>
          <a:ext cx="3085740" cy="2226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29" name="Prism 6" r:id="rId19" imgW="4157407" imgH="3000443" progId="Prism6.Document">
                  <p:embed/>
                </p:oleObj>
              </mc:Choice>
              <mc:Fallback>
                <p:oleObj name="Prism 6" r:id="rId19" imgW="4157407" imgH="3000443" progId="Prism6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265976" y="2949972"/>
                        <a:ext cx="3085740" cy="2226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Connector 4"/>
          <p:cNvCxnSpPr/>
          <p:nvPr/>
        </p:nvCxnSpPr>
        <p:spPr>
          <a:xfrm flipV="1">
            <a:off x="2170558" y="1459218"/>
            <a:ext cx="1715640" cy="3059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flipV="1">
            <a:off x="4136567" y="1465983"/>
            <a:ext cx="1715640" cy="3059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264192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307053" y="302903"/>
            <a:ext cx="2734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6970" y="5685832"/>
            <a:ext cx="120188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ar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raph showing  changes in the cell cycle  phases.  ISC-4 (0.5-3 µM) treatment after 24 hours induces cell death as evidenced by increase in sub G0/G1 population (black bars). 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/>
        </p:nvGraphicFramePr>
        <p:xfrm>
          <a:off x="6511800" y="1502329"/>
          <a:ext cx="5275263" cy="3181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18" name="Prism 6" r:id="rId3" imgW="5275490" imgH="3181701" progId="Prism6.Document">
                  <p:embed/>
                </p:oleObj>
              </mc:Choice>
              <mc:Fallback>
                <p:oleObj name="Prism 6" r:id="rId3" imgW="5275490" imgH="3181701" progId="Prism6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11800" y="1502329"/>
                        <a:ext cx="5275263" cy="3181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099617"/>
              </p:ext>
            </p:extLst>
          </p:nvPr>
        </p:nvGraphicFramePr>
        <p:xfrm>
          <a:off x="403225" y="1436688"/>
          <a:ext cx="5278438" cy="3248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719" name="Prism 6" r:id="rId5" imgW="5278149" imgH="3247509" progId="Prism6.Document">
                  <p:embed/>
                </p:oleObj>
              </mc:Choice>
              <mc:Fallback>
                <p:oleObj name="Prism 6" r:id="rId5" imgW="5278149" imgH="3247509" progId="Prism6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3225" y="1436688"/>
                        <a:ext cx="5278438" cy="3248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931916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323263" y="146839"/>
            <a:ext cx="2734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24772" y="5196984"/>
            <a:ext cx="11400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mbinatory effect of ISC-4 with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aunorubici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DNR)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Aza) or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venetoclax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VEN) in AML cell lines (OCI-AML3, MV4-11 and U937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2598"/>
              </p:ext>
            </p:extLst>
          </p:nvPr>
        </p:nvGraphicFramePr>
        <p:xfrm>
          <a:off x="1962150" y="1154113"/>
          <a:ext cx="7851775" cy="3497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9" name="Prism 6" r:id="rId3" imgW="7592381" imgH="3381846" progId="Prism6.Document">
                  <p:embed/>
                </p:oleObj>
              </mc:Choice>
              <mc:Fallback>
                <p:oleObj name="Prism 6" r:id="rId3" imgW="7592381" imgH="3381846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62150" y="1154113"/>
                        <a:ext cx="7851775" cy="3497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237104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118126" y="483594"/>
            <a:ext cx="7564664" cy="4903089"/>
            <a:chOff x="1047750" y="357188"/>
            <a:chExt cx="10120313" cy="6559550"/>
          </a:xfrm>
        </p:grpSpPr>
        <p:graphicFrame>
          <p:nvGraphicFramePr>
            <p:cNvPr id="4" name="Object 3"/>
            <p:cNvGraphicFramePr>
              <a:graphicFrameLocks noChangeAspect="1"/>
            </p:cNvGraphicFramePr>
            <p:nvPr/>
          </p:nvGraphicFramePr>
          <p:xfrm>
            <a:off x="4527550" y="373063"/>
            <a:ext cx="3135313" cy="3290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0" name="Prism 6" r:id="rId3" imgW="3135922" imgH="3291489" progId="Prism6.Document">
                    <p:embed/>
                  </p:oleObj>
                </mc:Choice>
                <mc:Fallback>
                  <p:oleObj name="Prism 6" r:id="rId3" imgW="3135922" imgH="3291489" progId="Prism6.Document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527550" y="373063"/>
                          <a:ext cx="3135313" cy="3290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/>
            <p:cNvGraphicFramePr>
              <a:graphicFrameLocks noChangeAspect="1"/>
            </p:cNvGraphicFramePr>
            <p:nvPr/>
          </p:nvGraphicFramePr>
          <p:xfrm>
            <a:off x="1168796" y="3762823"/>
            <a:ext cx="3135313" cy="3105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1" name="Prism 6" r:id="rId5" imgW="3135922" imgH="3105749" progId="Prism6.Document">
                    <p:embed/>
                  </p:oleObj>
                </mc:Choice>
                <mc:Fallback>
                  <p:oleObj name="Prism 6" r:id="rId5" imgW="3135922" imgH="3105749" progId="Prism6.Document">
                    <p:embed/>
                    <p:pic>
                      <p:nvPicPr>
                        <p:cNvPr id="5" name="Object 4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168796" y="3762823"/>
                          <a:ext cx="3135313" cy="3105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/>
            <p:cNvGraphicFramePr>
              <a:graphicFrameLocks noChangeAspect="1"/>
            </p:cNvGraphicFramePr>
            <p:nvPr/>
          </p:nvGraphicFramePr>
          <p:xfrm>
            <a:off x="1047750" y="357188"/>
            <a:ext cx="3135313" cy="31369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2" name="Prism 6" r:id="rId7" imgW="3135922" imgH="3137425" progId="Prism6.Document">
                    <p:embed/>
                  </p:oleObj>
                </mc:Choice>
                <mc:Fallback>
                  <p:oleObj name="Prism 6" r:id="rId7" imgW="3135922" imgH="3137425" progId="Prism6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47750" y="357188"/>
                          <a:ext cx="3135313" cy="31369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/>
          </p:nvGraphicFramePr>
          <p:xfrm>
            <a:off x="4600773" y="3773488"/>
            <a:ext cx="3135313" cy="3143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3" name="Prism 6" r:id="rId9" imgW="3135922" imgH="3143545" progId="Prism6.Document">
                    <p:embed/>
                  </p:oleObj>
                </mc:Choice>
                <mc:Fallback>
                  <p:oleObj name="Prism 6" r:id="rId9" imgW="3135922" imgH="3143545" progId="Prism6.Document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600773" y="3773488"/>
                          <a:ext cx="3135313" cy="3143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/>
          </p:nvGraphicFramePr>
          <p:xfrm>
            <a:off x="8032750" y="3773488"/>
            <a:ext cx="3135313" cy="3089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4" name="Prism 6" r:id="rId11" imgW="3135922" imgH="3088831" progId="Prism6.Document">
                    <p:embed/>
                  </p:oleObj>
                </mc:Choice>
                <mc:Fallback>
                  <p:oleObj name="Prism 6" r:id="rId11" imgW="3135922" imgH="3088831" progId="Prism6.Document">
                    <p:embed/>
                    <p:pic>
                      <p:nvPicPr>
                        <p:cNvPr id="8" name="Object 7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8032750" y="3773488"/>
                          <a:ext cx="3135313" cy="3089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/>
          </p:nvGraphicFramePr>
          <p:xfrm>
            <a:off x="8032750" y="357188"/>
            <a:ext cx="3135313" cy="3273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35" name="Prism 6" r:id="rId13" imgW="3135922" imgH="3273131" progId="Prism6.Document">
                    <p:embed/>
                  </p:oleObj>
                </mc:Choice>
                <mc:Fallback>
                  <p:oleObj name="Prism 6" r:id="rId13" imgW="3135922" imgH="3273131" progId="Prism6.Document">
                    <p:embed/>
                    <p:pic>
                      <p:nvPicPr>
                        <p:cNvPr id="9" name="Object 8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8032750" y="357188"/>
                          <a:ext cx="3135313" cy="3273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233681" y="252762"/>
            <a:ext cx="2734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33681" y="5466844"/>
            <a:ext cx="116890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7. Comparison of sensitivity of primary human AML cells with or without (wt.) indicated mutations (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.) to ISC-4 treatment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nsitivity was identified by IC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alues. NS; not significant.</a:t>
            </a:r>
          </a:p>
        </p:txBody>
      </p:sp>
    </p:spTree>
    <p:extLst>
      <p:ext uri="{BB962C8B-B14F-4D97-AF65-F5344CB8AC3E}">
        <p14:creationId xmlns:p14="http://schemas.microsoft.com/office/powerpoint/2010/main" val="5384245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660126" y="519654"/>
            <a:ext cx="455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770231" y="206349"/>
            <a:ext cx="4556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C11A248-D88D-4726-A29B-6194CD5D9D6E}"/>
              </a:ext>
            </a:extLst>
          </p:cNvPr>
          <p:cNvSpPr txBox="1"/>
          <p:nvPr/>
        </p:nvSpPr>
        <p:spPr>
          <a:xfrm>
            <a:off x="99892" y="-24483"/>
            <a:ext cx="2734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CB21396-30A8-44F7-949C-233B1A45D9C5}"/>
              </a:ext>
            </a:extLst>
          </p:cNvPr>
          <p:cNvSpPr txBox="1"/>
          <p:nvPr/>
        </p:nvSpPr>
        <p:spPr>
          <a:xfrm>
            <a:off x="204403" y="5621853"/>
            <a:ext cx="117878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8. ISC-4  reduces leukemic infiltration in the liver of mice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Luciferas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sRed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expressing C1498 (C1498-dsRed-Luc)-bearing albino B6 mice (n=3) were treated either with vehicle control (DMSO) or ISC-4 (7 mg/kg). Gross anatomy of livers at termination of with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hloroma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arrows)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&amp;E-stained histology of liver sections from Albino B6 mice treated with control (upper) or ISC-4 (lower). Magnification 4X.</a:t>
            </a:r>
            <a:endParaRPr lang="en-US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793967" y="298596"/>
            <a:ext cx="10619992" cy="5180575"/>
            <a:chOff x="793967" y="351864"/>
            <a:chExt cx="10619992" cy="5180575"/>
          </a:xfrm>
        </p:grpSpPr>
        <p:grpSp>
          <p:nvGrpSpPr>
            <p:cNvPr id="2" name="Group 1"/>
            <p:cNvGrpSpPr/>
            <p:nvPr/>
          </p:nvGrpSpPr>
          <p:grpSpPr>
            <a:xfrm>
              <a:off x="793967" y="351864"/>
              <a:ext cx="10619992" cy="5180575"/>
              <a:chOff x="777549" y="336802"/>
              <a:chExt cx="10619992" cy="5180575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777549" y="1440529"/>
                <a:ext cx="5466915" cy="2952626"/>
                <a:chOff x="1565268" y="466078"/>
                <a:chExt cx="5466915" cy="2952626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1679563" y="1069670"/>
                  <a:ext cx="155060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565268" y="2347124"/>
                  <a:ext cx="1608953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C-4 </a:t>
                  </a:r>
                </a:p>
                <a:p>
                  <a:pPr algn="ctr"/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7 mg/kg)</a:t>
                  </a:r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C5D25F3E-F2A7-46D4-A302-5CFEE424F939}"/>
                    </a:ext>
                  </a:extLst>
                </p:cNvPr>
                <p:cNvGrpSpPr/>
                <p:nvPr/>
              </p:nvGrpSpPr>
              <p:grpSpPr>
                <a:xfrm>
                  <a:off x="3095348" y="466078"/>
                  <a:ext cx="3936835" cy="2952626"/>
                  <a:chOff x="3095348" y="466077"/>
                  <a:chExt cx="8214804" cy="6161103"/>
                </a:xfrm>
              </p:grpSpPr>
              <p:pic>
                <p:nvPicPr>
                  <p:cNvPr id="16" name="Picture 15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bright="-20000" contrast="-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95348" y="466077"/>
                    <a:ext cx="8214804" cy="616110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</p:pic>
              <p:sp>
                <p:nvSpPr>
                  <p:cNvPr id="17" name="Right Arrow 16"/>
                  <p:cNvSpPr/>
                  <p:nvPr/>
                </p:nvSpPr>
                <p:spPr>
                  <a:xfrm rot="8230976">
                    <a:off x="4107126" y="649996"/>
                    <a:ext cx="991665" cy="602955"/>
                  </a:xfrm>
                  <a:prstGeom prst="rightArrow">
                    <a:avLst>
                      <a:gd name="adj1" fmla="val 32677"/>
                      <a:gd name="adj2" fmla="val 85435"/>
                    </a:avLst>
                  </a:prstGeom>
                  <a:solidFill>
                    <a:schemeClr val="bg1"/>
                  </a:solidFill>
                  <a:ln w="254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8" name="Right Arrow 8">
                    <a:extLst>
                      <a:ext uri="{FF2B5EF4-FFF2-40B4-BE49-F238E27FC236}">
                        <a16:creationId xmlns:a16="http://schemas.microsoft.com/office/drawing/2014/main" id="{0F396197-2AB8-4CBE-9149-4D5F783F9589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90247" y="2486450"/>
                    <a:ext cx="974790" cy="635052"/>
                  </a:xfrm>
                  <a:prstGeom prst="rightArrow">
                    <a:avLst>
                      <a:gd name="adj1" fmla="val 32677"/>
                      <a:gd name="adj2" fmla="val 85435"/>
                    </a:avLst>
                  </a:prstGeom>
                  <a:solidFill>
                    <a:schemeClr val="bg1"/>
                  </a:solidFill>
                  <a:ln w="254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9" name="Right Arrow 8">
                    <a:extLst>
                      <a:ext uri="{FF2B5EF4-FFF2-40B4-BE49-F238E27FC236}">
                        <a16:creationId xmlns:a16="http://schemas.microsoft.com/office/drawing/2014/main" id="{EDA8C305-16B2-4519-83DE-51AC13F5756C}"/>
                      </a:ext>
                    </a:extLst>
                  </p:cNvPr>
                  <p:cNvSpPr/>
                  <p:nvPr/>
                </p:nvSpPr>
                <p:spPr>
                  <a:xfrm rot="1669192">
                    <a:off x="6878597" y="588949"/>
                    <a:ext cx="998442" cy="650461"/>
                  </a:xfrm>
                  <a:prstGeom prst="rightArrow">
                    <a:avLst>
                      <a:gd name="adj1" fmla="val 32677"/>
                      <a:gd name="adj2" fmla="val 85435"/>
                    </a:avLst>
                  </a:prstGeom>
                  <a:solidFill>
                    <a:schemeClr val="bg1"/>
                  </a:solidFill>
                  <a:ln w="254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20" name="Right Arrow 8">
                    <a:extLst>
                      <a:ext uri="{FF2B5EF4-FFF2-40B4-BE49-F238E27FC236}">
                        <a16:creationId xmlns:a16="http://schemas.microsoft.com/office/drawing/2014/main" id="{D1E290EC-5231-4816-B860-FC0314082596}"/>
                      </a:ext>
                    </a:extLst>
                  </p:cNvPr>
                  <p:cNvSpPr/>
                  <p:nvPr/>
                </p:nvSpPr>
                <p:spPr>
                  <a:xfrm rot="17399826">
                    <a:off x="7536146" y="2381487"/>
                    <a:ext cx="1003194" cy="653557"/>
                  </a:xfrm>
                  <a:prstGeom prst="rightArrow">
                    <a:avLst>
                      <a:gd name="adj1" fmla="val 32677"/>
                      <a:gd name="adj2" fmla="val 85435"/>
                    </a:avLst>
                  </a:prstGeom>
                  <a:solidFill>
                    <a:schemeClr val="bg1"/>
                  </a:solidFill>
                  <a:ln w="254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cxnSp>
            <p:nvCxnSpPr>
              <p:cNvPr id="13" name="Straight Connector 12"/>
              <p:cNvCxnSpPr/>
              <p:nvPr/>
            </p:nvCxnSpPr>
            <p:spPr>
              <a:xfrm flipV="1">
                <a:off x="5169014" y="336803"/>
                <a:ext cx="2872416" cy="1435366"/>
              </a:xfrm>
              <a:prstGeom prst="line">
                <a:avLst/>
              </a:prstGeom>
              <a:ln w="25400" cmpd="sng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5169014" y="2044121"/>
                <a:ext cx="2891035" cy="666009"/>
              </a:xfrm>
              <a:prstGeom prst="line">
                <a:avLst/>
              </a:prstGeom>
              <a:ln w="25400" cmpd="sng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 flipV="1">
                <a:off x="5119492" y="3140290"/>
                <a:ext cx="2921938" cy="168699"/>
              </a:xfrm>
              <a:prstGeom prst="line">
                <a:avLst/>
              </a:prstGeom>
              <a:ln w="25400" cmpd="sng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5119492" y="3574209"/>
                <a:ext cx="2921938" cy="1943168"/>
              </a:xfrm>
              <a:prstGeom prst="line">
                <a:avLst/>
              </a:prstGeom>
              <a:ln w="25400" cmpd="sng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41430" y="336802"/>
                <a:ext cx="3337493" cy="2373328"/>
              </a:xfrm>
              <a:prstGeom prst="rect">
                <a:avLst/>
              </a:prstGeom>
              <a:ln w="25400">
                <a:solidFill>
                  <a:schemeClr val="tx1"/>
                </a:solidFill>
              </a:ln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060048" y="3144049"/>
                <a:ext cx="3337493" cy="2373328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sp>
          <p:nvSpPr>
            <p:cNvPr id="11" name="Rectangle 10"/>
            <p:cNvSpPr/>
            <p:nvPr/>
          </p:nvSpPr>
          <p:spPr>
            <a:xfrm>
              <a:off x="4741176" y="1772169"/>
              <a:ext cx="427838" cy="265220"/>
            </a:xfrm>
            <a:prstGeom prst="rect">
              <a:avLst/>
            </a:prstGeom>
            <a:noFill/>
            <a:ln w="317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691654" y="3308989"/>
              <a:ext cx="427838" cy="265220"/>
            </a:xfrm>
            <a:prstGeom prst="rect">
              <a:avLst/>
            </a:prstGeom>
            <a:noFill/>
            <a:ln w="317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648954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2</TotalTime>
  <Words>638</Words>
  <Application>Microsoft Office PowerPoint</Application>
  <PresentationFormat>Widescreen</PresentationFormat>
  <Paragraphs>87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GraphPad Prism 6 Project</vt:lpstr>
      <vt:lpstr>Prism 6</vt:lpstr>
      <vt:lpstr>Supplementary Figure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enn State Hershe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yguly Annageldiyev</dc:creator>
  <cp:lastModifiedBy>Annageldiyev, Charyguly</cp:lastModifiedBy>
  <cp:revision>293</cp:revision>
  <dcterms:created xsi:type="dcterms:W3CDTF">2019-11-11T00:18:39Z</dcterms:created>
  <dcterms:modified xsi:type="dcterms:W3CDTF">2020-03-16T19:42:47Z</dcterms:modified>
</cp:coreProperties>
</file>